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789" r:id="rId3"/>
    <p:sldId id="790" r:id="rId4"/>
    <p:sldId id="1031" r:id="rId5"/>
  </p:sldIdLst>
  <p:sldSz cx="12192000" cy="6858000"/>
  <p:notesSz cx="7011988" cy="92979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03BD"/>
    <a:srgbClr val="E226B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95" d="100"/>
          <a:sy n="95" d="100"/>
        </p:scale>
        <p:origin x="1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5" indent="0" algn="ctr">
              <a:buNone/>
              <a:defRPr sz="2000"/>
            </a:lvl2pPr>
            <a:lvl3pPr marL="914409" indent="0" algn="ctr">
              <a:buNone/>
              <a:defRPr sz="1800"/>
            </a:lvl3pPr>
            <a:lvl4pPr marL="1371614" indent="0" algn="ctr">
              <a:buNone/>
              <a:defRPr sz="1600"/>
            </a:lvl4pPr>
            <a:lvl5pPr marL="1828818" indent="0" algn="ctr">
              <a:buNone/>
              <a:defRPr sz="1600"/>
            </a:lvl5pPr>
            <a:lvl6pPr marL="2286023" indent="0" algn="ctr">
              <a:buNone/>
              <a:defRPr sz="1600"/>
            </a:lvl6pPr>
            <a:lvl7pPr marL="2743227" indent="0" algn="ctr">
              <a:buNone/>
              <a:defRPr sz="1600"/>
            </a:lvl7pPr>
            <a:lvl8pPr marL="3200432" indent="0" algn="ctr">
              <a:buNone/>
              <a:defRPr sz="1600"/>
            </a:lvl8pPr>
            <a:lvl9pPr marL="365763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6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21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2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15687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47308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74213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21644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31326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82075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5216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80266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95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FAE7126-619C-4F60-B947-EE2A832CE45A}"/>
              </a:ext>
            </a:extLst>
          </p:cNvPr>
          <p:cNvSpPr txBox="1"/>
          <p:nvPr userDrawn="1"/>
        </p:nvSpPr>
        <p:spPr>
          <a:xfrm>
            <a:off x="1" y="88655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88FEC08-F4DB-407E-A6B9-A1027581052A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/>
          <a:stretch>
            <a:fillRect/>
          </a:stretch>
        </p:blipFill>
        <p:spPr>
          <a:xfrm>
            <a:off x="11321873" y="6207092"/>
            <a:ext cx="850465" cy="6378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30711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93716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33446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07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1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3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66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29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5" indent="0">
              <a:buNone/>
              <a:defRPr sz="2000" b="1"/>
            </a:lvl2pPr>
            <a:lvl3pPr marL="914409" indent="0">
              <a:buNone/>
              <a:defRPr sz="1800" b="1"/>
            </a:lvl3pPr>
            <a:lvl4pPr marL="1371614" indent="0">
              <a:buNone/>
              <a:defRPr sz="1600" b="1"/>
            </a:lvl4pPr>
            <a:lvl5pPr marL="1828818" indent="0">
              <a:buNone/>
              <a:defRPr sz="1600" b="1"/>
            </a:lvl5pPr>
            <a:lvl6pPr marL="2286023" indent="0">
              <a:buNone/>
              <a:defRPr sz="1600" b="1"/>
            </a:lvl6pPr>
            <a:lvl7pPr marL="2743227" indent="0">
              <a:buNone/>
              <a:defRPr sz="1600" b="1"/>
            </a:lvl7pPr>
            <a:lvl8pPr marL="3200432" indent="0">
              <a:buNone/>
              <a:defRPr sz="1600" b="1"/>
            </a:lvl8pPr>
            <a:lvl9pPr marL="365763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92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BEA79D-5C92-4E29-AE2E-3549BE526C0A}"/>
              </a:ext>
            </a:extLst>
          </p:cNvPr>
          <p:cNvSpPr txBox="1"/>
          <p:nvPr userDrawn="1"/>
        </p:nvSpPr>
        <p:spPr>
          <a:xfrm>
            <a:off x="1" y="85617"/>
            <a:ext cx="12192000" cy="646331"/>
          </a:xfrm>
          <a:prstGeom prst="rect">
            <a:avLst/>
          </a:prstGeom>
          <a:solidFill>
            <a:srgbClr val="3333CC"/>
          </a:solidFill>
        </p:spPr>
        <p:txBody>
          <a:bodyPr wrap="square" rtlCol="0" anchor="ctr">
            <a:spAutoFit/>
          </a:bodyPr>
          <a:lstStyle/>
          <a:p>
            <a:pPr algn="ctr"/>
            <a:endParaRPr lang="en-US" sz="3600" b="1" dirty="0">
              <a:solidFill>
                <a:schemeClr val="bg1"/>
              </a:solidFill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081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0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578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5" indent="0">
              <a:buNone/>
              <a:defRPr sz="2800"/>
            </a:lvl2pPr>
            <a:lvl3pPr marL="914409" indent="0">
              <a:buNone/>
              <a:defRPr sz="2400"/>
            </a:lvl3pPr>
            <a:lvl4pPr marL="1371614" indent="0">
              <a:buNone/>
              <a:defRPr sz="2000"/>
            </a:lvl4pPr>
            <a:lvl5pPr marL="1828818" indent="0">
              <a:buNone/>
              <a:defRPr sz="2000"/>
            </a:lvl5pPr>
            <a:lvl6pPr marL="2286023" indent="0">
              <a:buNone/>
              <a:defRPr sz="2000"/>
            </a:lvl6pPr>
            <a:lvl7pPr marL="2743227" indent="0">
              <a:buNone/>
              <a:defRPr sz="2000"/>
            </a:lvl7pPr>
            <a:lvl8pPr marL="3200432" indent="0">
              <a:buNone/>
              <a:defRPr sz="2000"/>
            </a:lvl8pPr>
            <a:lvl9pPr marL="3657637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5" indent="0">
              <a:buNone/>
              <a:defRPr sz="1400"/>
            </a:lvl2pPr>
            <a:lvl3pPr marL="914409" indent="0">
              <a:buNone/>
              <a:defRPr sz="1200"/>
            </a:lvl3pPr>
            <a:lvl4pPr marL="1371614" indent="0">
              <a:buNone/>
              <a:defRPr sz="1000"/>
            </a:lvl4pPr>
            <a:lvl5pPr marL="1828818" indent="0">
              <a:buNone/>
              <a:defRPr sz="1000"/>
            </a:lvl5pPr>
            <a:lvl6pPr marL="2286023" indent="0">
              <a:buNone/>
              <a:defRPr sz="1000"/>
            </a:lvl6pPr>
            <a:lvl7pPr marL="2743227" indent="0">
              <a:buNone/>
              <a:defRPr sz="1000"/>
            </a:lvl7pPr>
            <a:lvl8pPr marL="3200432" indent="0">
              <a:buNone/>
              <a:defRPr sz="1000"/>
            </a:lvl8pPr>
            <a:lvl9pPr marL="365763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E9610-F477-4B7E-8559-275AF9B5D401}" type="datetimeFigureOut">
              <a:rPr lang="en-US" smtClean="0"/>
              <a:pPr/>
              <a:t>5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7FA7B-80AF-4E5F-BBA0-995ACFDFD47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034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AF032E-6009-4DF4-BC5D-A56E6D51A59A}" type="datetimeFigureOut">
              <a:rPr lang="en-IN" smtClean="0"/>
              <a:t>31-05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DE3CA-9A9B-475E-B638-D42AB8F0376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02573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9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2" indent="-228602" algn="l" defTabSz="914409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7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16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1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25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0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34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39" indent="-228602" algn="l" defTabSz="914409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5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9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4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18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3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2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32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37" algn="l" defTabSz="91440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B757B-5F4D-40CA-A6DA-E82A16D545FD}" type="datetimeFigureOut">
              <a:rPr lang="en-US" smtClean="0"/>
              <a:t>5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2C5B1-E76E-4563-8184-E273F32BAE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83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3C0AEFB-D09D-4945-AC05-88A58EAC505A}"/>
              </a:ext>
            </a:extLst>
          </p:cNvPr>
          <p:cNvSpPr txBox="1"/>
          <p:nvPr/>
        </p:nvSpPr>
        <p:spPr>
          <a:xfrm>
            <a:off x="418743" y="105059"/>
            <a:ext cx="11331723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6  Cytotoxicity Profiling of AR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RPC/NEPC (PC-3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PC-3M)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d Taxane Resistance AR</a:t>
            </a:r>
            <a:r>
              <a:rPr kumimoji="0" lang="en-US" sz="1100" b="1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ow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CRPC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DUTXR)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C-3,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C-3M and DUTXR cell lines were treated with CONV-TOPO, METRO-TOPO, CONV-DTX and combination (CONV-DTX+METRO-TOPO) treatment, and cell cytotoxicity and caspase3/7 levels ware assed </a:t>
            </a: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ytotoxicity profiling by MTT showed combination (CONV-DTX+METRO-TOPO) reduces highest cell survival compared with other treatments for all PCa cell lines,  CONV-TOPO&gt;CONV-DTX&gt;METRO-TOPO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)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pase3/7 activity showed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ombination (CONV-DTX+METRO-TOPO) treatment </a:t>
            </a:r>
            <a:r>
              <a:rPr kumimoji="0" lang="it-IT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educed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poptosis the </a:t>
            </a:r>
            <a:r>
              <a:rPr kumimoji="0" lang="it-IT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reatest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compared to other treatments in all cell lines. </a:t>
            </a:r>
            <a:r>
              <a:rPr lang="it-IT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ytation5 images showed treatment effects on the cell lines PC-3M and DUTXR. Results showed significantly higher cell death in METRO compared to CONV treatment for both the cell lines and combination (CONV-DTX+METRO-TOPO) treatment reduced cell death greater for both PCa cell lines. ImageJ analysis showed significant differences in cell density for CONV-TOPO, CONV-DTX, METRO-TOPO, and combination (CONV-DTX+METRO-TOPO) treatment in PC-3, PC-3M, and DUTXR cell lines. (*p ≤ 0.05).</a:t>
            </a:r>
            <a:endParaRPr kumimoji="0" lang="it-IT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340844-98D1-4B3E-9A7C-AB2BC99437E3}"/>
              </a:ext>
            </a:extLst>
          </p:cNvPr>
          <p:cNvSpPr txBox="1"/>
          <p:nvPr/>
        </p:nvSpPr>
        <p:spPr>
          <a:xfrm>
            <a:off x="436332" y="1845022"/>
            <a:ext cx="1986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6A 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84D65EC-6F8A-8913-6EC6-083ED8F51548}"/>
              </a:ext>
            </a:extLst>
          </p:cNvPr>
          <p:cNvGrpSpPr/>
          <p:nvPr/>
        </p:nvGrpSpPr>
        <p:grpSpPr>
          <a:xfrm>
            <a:off x="2165761" y="1906889"/>
            <a:ext cx="7884472" cy="3826479"/>
            <a:chOff x="2165761" y="1906889"/>
            <a:chExt cx="7884472" cy="3826479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CB9A5DE-67E3-4DD5-81A8-33BE7477D378}"/>
                </a:ext>
              </a:extLst>
            </p:cNvPr>
            <p:cNvGrpSpPr/>
            <p:nvPr/>
          </p:nvGrpSpPr>
          <p:grpSpPr>
            <a:xfrm>
              <a:off x="2165761" y="1913677"/>
              <a:ext cx="7837685" cy="3819691"/>
              <a:chOff x="2216146" y="1529114"/>
              <a:chExt cx="7837685" cy="3819691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A44E1B03-7BD7-488D-A963-16948E563DD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70759265"/>
                  </p:ext>
                </p:extLst>
              </p:nvPr>
            </p:nvGraphicFramePr>
            <p:xfrm>
              <a:off x="7478933" y="1529114"/>
              <a:ext cx="2574898" cy="381969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2922829" imgH="4335378" progId="Prism8.Document">
                      <p:embed/>
                    </p:oleObj>
                  </mc:Choice>
                  <mc:Fallback>
                    <p:oleObj name="Prism 8" r:id="rId2" imgW="2922829" imgH="4335378" progId="Prism8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FC8D4461-932C-4B3A-9255-E73E24F3A84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7478933" y="1529114"/>
                            <a:ext cx="2574898" cy="3819691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>
                <a:extLst>
                  <a:ext uri="{FF2B5EF4-FFF2-40B4-BE49-F238E27FC236}">
                    <a16:creationId xmlns:a16="http://schemas.microsoft.com/office/drawing/2014/main" id="{D4BDA3E3-F7BC-45B2-9364-68041443E13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93184998"/>
                  </p:ext>
                </p:extLst>
              </p:nvPr>
            </p:nvGraphicFramePr>
            <p:xfrm>
              <a:off x="2216146" y="1529115"/>
              <a:ext cx="2574898" cy="381969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2922829" imgH="4335378" progId="Prism8.Document">
                      <p:embed/>
                    </p:oleObj>
                  </mc:Choice>
                  <mc:Fallback>
                    <p:oleObj name="Prism 8" r:id="rId4" imgW="2922829" imgH="4335378" progId="Prism8.Document">
                      <p:embed/>
                      <p:pic>
                        <p:nvPicPr>
                          <p:cNvPr id="7" name="Object 6">
                            <a:extLst>
                              <a:ext uri="{FF2B5EF4-FFF2-40B4-BE49-F238E27FC236}">
                                <a16:creationId xmlns:a16="http://schemas.microsoft.com/office/drawing/2014/main" id="{FC478960-86FD-4531-BDA4-074F5484A72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216146" y="1529115"/>
                            <a:ext cx="2574898" cy="3819690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2C76B491-3D80-41DB-BA4C-F9C0B1F9C3FE}"/>
                  </a:ext>
                </a:extLst>
              </p:cNvPr>
              <p:cNvSpPr/>
              <p:nvPr/>
            </p:nvSpPr>
            <p:spPr>
              <a:xfrm>
                <a:off x="8695049" y="1638037"/>
                <a:ext cx="965674" cy="1880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1F345E4F-B565-4845-B3F9-64F5CCD4D8D7}"/>
                  </a:ext>
                </a:extLst>
              </p:cNvPr>
              <p:cNvSpPr/>
              <p:nvPr/>
            </p:nvSpPr>
            <p:spPr>
              <a:xfrm>
                <a:off x="6143677" y="1628067"/>
                <a:ext cx="965674" cy="1880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4F9D00EC-BF3B-4A95-970B-EB79DC13AD04}"/>
                  </a:ext>
                </a:extLst>
              </p:cNvPr>
              <p:cNvSpPr/>
              <p:nvPr/>
            </p:nvSpPr>
            <p:spPr>
              <a:xfrm>
                <a:off x="3485283" y="1660826"/>
                <a:ext cx="965674" cy="18800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23A9D74-7A0A-4658-82B9-061F4CC076A3}"/>
                  </a:ext>
                </a:extLst>
              </p:cNvPr>
              <p:cNvSpPr txBox="1"/>
              <p:nvPr/>
            </p:nvSpPr>
            <p:spPr>
              <a:xfrm>
                <a:off x="3089038" y="1529114"/>
                <a:ext cx="126669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TT- PC-3</a:t>
                </a:r>
                <a:r>
                  <a: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C</a:t>
                </a:r>
                <a:r>
                  <a:rPr kumimoji="0" lang="en-US" sz="12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8AA68F6-DC34-4AB7-BD60-43AE51A92F71}"/>
                  </a:ext>
                </a:extLst>
              </p:cNvPr>
              <p:cNvSpPr txBox="1"/>
              <p:nvPr/>
            </p:nvSpPr>
            <p:spPr>
              <a:xfrm>
                <a:off x="8289778" y="1539075"/>
                <a:ext cx="14462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TT- DUTXR-IC</a:t>
                </a:r>
                <a:r>
                  <a:rPr kumimoji="0" lang="en-US" sz="12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</p:grpSp>
        <p:graphicFrame>
          <p:nvGraphicFramePr>
            <p:cNvPr id="17" name="Object 16">
              <a:extLst>
                <a:ext uri="{FF2B5EF4-FFF2-40B4-BE49-F238E27FC236}">
                  <a16:creationId xmlns:a16="http://schemas.microsoft.com/office/drawing/2014/main" id="{AEBDC928-D297-4513-95C9-8BE57690354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58145008"/>
                </p:ext>
              </p:extLst>
            </p:nvPr>
          </p:nvGraphicFramePr>
          <p:xfrm>
            <a:off x="4787446" y="1913677"/>
            <a:ext cx="2574898" cy="38196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922829" imgH="4335378" progId="Prism8.Document">
                    <p:embed/>
                  </p:oleObj>
                </mc:Choice>
                <mc:Fallback>
                  <p:oleObj name="Prism 8" r:id="rId6" imgW="2922829" imgH="4335378" progId="Prism8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983B9CC6-C177-448C-A539-90584599A68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787446" y="1913677"/>
                          <a:ext cx="2574898" cy="3819690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3026DDE-09CD-465E-A890-FF1BA0CEFB66}"/>
                </a:ext>
              </a:extLst>
            </p:cNvPr>
            <p:cNvSpPr/>
            <p:nvPr/>
          </p:nvSpPr>
          <p:spPr>
            <a:xfrm>
              <a:off x="6009796" y="2012629"/>
              <a:ext cx="895206" cy="1880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57CF16C-B797-422B-977A-F2558C9E227F}"/>
                </a:ext>
              </a:extLst>
            </p:cNvPr>
            <p:cNvSpPr txBox="1"/>
            <p:nvPr/>
          </p:nvSpPr>
          <p:spPr>
            <a:xfrm>
              <a:off x="5521462" y="1906889"/>
              <a:ext cx="1394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T- PC-3M</a:t>
              </a:r>
              <a:r>
                <a:rPr kumimoji="0" lang="en-US" sz="12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-IC</a:t>
              </a:r>
              <a:r>
                <a:rPr kumimoji="0" lang="en-US" sz="1200" b="1" i="0" u="none" strike="noStrike" kern="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6E4A7D0-7ED5-AE5C-6FD2-8595E8F076E6}"/>
                </a:ext>
              </a:extLst>
            </p:cNvPr>
            <p:cNvSpPr txBox="1"/>
            <p:nvPr/>
          </p:nvSpPr>
          <p:spPr>
            <a:xfrm>
              <a:off x="4012748" y="34375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E9563C6-33DA-505E-F0B7-F6C714CB747B}"/>
                </a:ext>
              </a:extLst>
            </p:cNvPr>
            <p:cNvSpPr txBox="1"/>
            <p:nvPr/>
          </p:nvSpPr>
          <p:spPr>
            <a:xfrm>
              <a:off x="4306602" y="3484614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B2E3548-BE20-CEA1-6B08-5FAEE7AC33C7}"/>
                </a:ext>
              </a:extLst>
            </p:cNvPr>
            <p:cNvSpPr txBox="1"/>
            <p:nvPr/>
          </p:nvSpPr>
          <p:spPr>
            <a:xfrm>
              <a:off x="6632344" y="335846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408239C-EC3E-B3CB-09B6-83BAA62C6661}"/>
                </a:ext>
              </a:extLst>
            </p:cNvPr>
            <p:cNvSpPr txBox="1"/>
            <p:nvPr/>
          </p:nvSpPr>
          <p:spPr>
            <a:xfrm>
              <a:off x="6933096" y="3406829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3603FF8-8D87-2786-5546-FE48DFC4940C}"/>
                </a:ext>
              </a:extLst>
            </p:cNvPr>
            <p:cNvSpPr txBox="1"/>
            <p:nvPr/>
          </p:nvSpPr>
          <p:spPr>
            <a:xfrm>
              <a:off x="9271261" y="355834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63DB149-9AF4-91FB-B407-7A83E7A659AB}"/>
                </a:ext>
              </a:extLst>
            </p:cNvPr>
            <p:cNvSpPr txBox="1"/>
            <p:nvPr/>
          </p:nvSpPr>
          <p:spPr>
            <a:xfrm>
              <a:off x="9572405" y="359833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5822E9C-DDC0-BCC3-A413-732C737B1162}"/>
                </a:ext>
              </a:extLst>
            </p:cNvPr>
            <p:cNvSpPr txBox="1"/>
            <p:nvPr/>
          </p:nvSpPr>
          <p:spPr>
            <a:xfrm>
              <a:off x="3103484" y="2155509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8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37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37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0nM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A129D3D-B518-5C95-804A-092038AF3B1D}"/>
                </a:ext>
              </a:extLst>
            </p:cNvPr>
            <p:cNvSpPr txBox="1"/>
            <p:nvPr/>
          </p:nvSpPr>
          <p:spPr>
            <a:xfrm>
              <a:off x="5732947" y="2190583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27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4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29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40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29nM)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2236F89-28E7-6017-FEF3-357D6EC16154}"/>
                </a:ext>
              </a:extLst>
            </p:cNvPr>
            <p:cNvSpPr txBox="1"/>
            <p:nvPr/>
          </p:nvSpPr>
          <p:spPr>
            <a:xfrm>
              <a:off x="8363745" y="2218733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11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46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2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466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2nM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50516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EE4EEC3E-B4C6-843C-4537-1F16034FB62C}"/>
              </a:ext>
            </a:extLst>
          </p:cNvPr>
          <p:cNvSpPr txBox="1"/>
          <p:nvPr/>
        </p:nvSpPr>
        <p:spPr>
          <a:xfrm>
            <a:off x="429344" y="931970"/>
            <a:ext cx="1986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6B 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6E9C86E-49CA-74AB-0F91-20B25F19E785}"/>
              </a:ext>
            </a:extLst>
          </p:cNvPr>
          <p:cNvGrpSpPr/>
          <p:nvPr/>
        </p:nvGrpSpPr>
        <p:grpSpPr>
          <a:xfrm>
            <a:off x="2181195" y="1090903"/>
            <a:ext cx="7829580" cy="4322707"/>
            <a:chOff x="2181195" y="1090903"/>
            <a:chExt cx="7829580" cy="4322707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2BA3B10-2DF5-478B-972E-ACAC48F7EED1}"/>
                </a:ext>
              </a:extLst>
            </p:cNvPr>
            <p:cNvGrpSpPr/>
            <p:nvPr/>
          </p:nvGrpSpPr>
          <p:grpSpPr>
            <a:xfrm>
              <a:off x="2181195" y="1092816"/>
              <a:ext cx="7829580" cy="4320794"/>
              <a:chOff x="2217517" y="1372909"/>
              <a:chExt cx="7829580" cy="4320794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DEB61D3C-D7A2-40B6-A464-A40B84E5AD3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66035115"/>
                  </p:ext>
                </p:extLst>
              </p:nvPr>
            </p:nvGraphicFramePr>
            <p:xfrm>
              <a:off x="7495985" y="1746943"/>
              <a:ext cx="2551112" cy="39385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2808363" imgH="4335378" progId="Prism8.Document">
                      <p:embed/>
                    </p:oleObj>
                  </mc:Choice>
                  <mc:Fallback>
                    <p:oleObj name="Prism 8" r:id="rId2" imgW="2808363" imgH="4335378" progId="Prism8.Document">
                      <p:embed/>
                      <p:pic>
                        <p:nvPicPr>
                          <p:cNvPr id="2" name="Object 1">
                            <a:extLst>
                              <a:ext uri="{FF2B5EF4-FFF2-40B4-BE49-F238E27FC236}">
                                <a16:creationId xmlns:a16="http://schemas.microsoft.com/office/drawing/2014/main" id="{E1D59659-CE30-4C9C-8D5E-2419822945C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7495985" y="1746943"/>
                            <a:ext cx="2551112" cy="3938588"/>
                          </a:xfrm>
                          <a:prstGeom prst="rect">
                            <a:avLst/>
                          </a:prstGeom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B44D579E-862F-42EF-8EAD-2305732FD25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05749649"/>
                  </p:ext>
                </p:extLst>
              </p:nvPr>
            </p:nvGraphicFramePr>
            <p:xfrm>
              <a:off x="4908360" y="1746943"/>
              <a:ext cx="2552700" cy="39385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2808363" imgH="4335378" progId="Prism8.Document">
                      <p:embed/>
                    </p:oleObj>
                  </mc:Choice>
                  <mc:Fallback>
                    <p:oleObj name="Prism 8" r:id="rId4" imgW="2808363" imgH="4335378" progId="Prism8.Document">
                      <p:embed/>
                      <p:pic>
                        <p:nvPicPr>
                          <p:cNvPr id="4" name="Object 3">
                            <a:extLst>
                              <a:ext uri="{FF2B5EF4-FFF2-40B4-BE49-F238E27FC236}">
                                <a16:creationId xmlns:a16="http://schemas.microsoft.com/office/drawing/2014/main" id="{ABC612EC-D3D0-477E-892A-824D826165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4908360" y="1746943"/>
                            <a:ext cx="2552700" cy="3938588"/>
                          </a:xfrm>
                          <a:prstGeom prst="rect">
                            <a:avLst/>
                          </a:prstGeom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5F7A19DC-A181-4730-AB2B-0896CE5DBC90}"/>
                  </a:ext>
                </a:extLst>
              </p:cNvPr>
              <p:cNvSpPr/>
              <p:nvPr/>
            </p:nvSpPr>
            <p:spPr>
              <a:xfrm>
                <a:off x="6024785" y="1862983"/>
                <a:ext cx="1034041" cy="2392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1BD9799-1480-4ED3-916D-5C0C370F2053}"/>
                  </a:ext>
                </a:extLst>
              </p:cNvPr>
              <p:cNvSpPr txBox="1"/>
              <p:nvPr/>
            </p:nvSpPr>
            <p:spPr>
              <a:xfrm>
                <a:off x="5405746" y="1372909"/>
                <a:ext cx="19207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pase3/7- PC-3M</a:t>
                </a:r>
                <a:r>
                  <a: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C</a:t>
                </a:r>
                <a:r>
                  <a:rPr kumimoji="0" lang="en-US" sz="12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9ABF71A2-6FFD-4447-AEB7-246F78368BDC}"/>
                  </a:ext>
                </a:extLst>
              </p:cNvPr>
              <p:cNvSpPr/>
              <p:nvPr/>
            </p:nvSpPr>
            <p:spPr>
              <a:xfrm>
                <a:off x="8576645" y="1862983"/>
                <a:ext cx="1080103" cy="23928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597AF0C-02D6-4569-9987-84FB96EE076D}"/>
                  </a:ext>
                </a:extLst>
              </p:cNvPr>
              <p:cNvSpPr txBox="1"/>
              <p:nvPr/>
            </p:nvSpPr>
            <p:spPr>
              <a:xfrm>
                <a:off x="7872697" y="1378212"/>
                <a:ext cx="19800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aspase3/7- DUTXR-IC</a:t>
                </a:r>
                <a:r>
                  <a:rPr kumimoji="0" lang="en-US" sz="12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C956F26-3D31-459F-8104-15FE1C6DA666}"/>
                  </a:ext>
                </a:extLst>
              </p:cNvPr>
              <p:cNvSpPr txBox="1"/>
              <p:nvPr/>
            </p:nvSpPr>
            <p:spPr>
              <a:xfrm>
                <a:off x="2807931" y="1393946"/>
                <a:ext cx="17924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spase3/7- PC-3</a:t>
                </a:r>
                <a:r>
                  <a:rPr kumimoji="0" lang="en-US" sz="1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C</a:t>
                </a:r>
                <a:r>
                  <a:rPr kumimoji="0" lang="en-US" sz="12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B22E663-8EF6-4A4D-B8ED-77BCA80D3A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3093" t="10931"/>
              <a:stretch/>
            </p:blipFill>
            <p:spPr>
              <a:xfrm>
                <a:off x="2217517" y="1926271"/>
                <a:ext cx="2656315" cy="3767432"/>
              </a:xfrm>
              <a:prstGeom prst="rect">
                <a:avLst/>
              </a:prstGeom>
              <a:ln>
                <a:noFill/>
              </a:ln>
            </p:spPr>
          </p:pic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0E55C59-A0A3-CEF4-5775-9B697A9B5AE8}"/>
                </a:ext>
              </a:extLst>
            </p:cNvPr>
            <p:cNvSpPr txBox="1"/>
            <p:nvPr/>
          </p:nvSpPr>
          <p:spPr>
            <a:xfrm>
              <a:off x="3026313" y="1322950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8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37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37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0nM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27C18E8-0254-47F7-0175-D7AC289C9D97}"/>
                </a:ext>
              </a:extLst>
            </p:cNvPr>
            <p:cNvSpPr txBox="1"/>
            <p:nvPr/>
          </p:nvSpPr>
          <p:spPr>
            <a:xfrm>
              <a:off x="4374439" y="2209280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F0E1DBB-7003-56EB-0C13-3EEB34863554}"/>
                </a:ext>
              </a:extLst>
            </p:cNvPr>
            <p:cNvSpPr txBox="1"/>
            <p:nvPr/>
          </p:nvSpPr>
          <p:spPr>
            <a:xfrm>
              <a:off x="4038508" y="228555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69715D9-A2E8-C31F-9008-335CA36CCFAB}"/>
                </a:ext>
              </a:extLst>
            </p:cNvPr>
            <p:cNvSpPr txBox="1"/>
            <p:nvPr/>
          </p:nvSpPr>
          <p:spPr>
            <a:xfrm>
              <a:off x="5495253" y="1266597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27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4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29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40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29nM)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F061801-8BEA-C552-559A-160F370067C9}"/>
                </a:ext>
              </a:extLst>
            </p:cNvPr>
            <p:cNvSpPr/>
            <p:nvPr/>
          </p:nvSpPr>
          <p:spPr>
            <a:xfrm>
              <a:off x="4963209" y="1092816"/>
              <a:ext cx="2460947" cy="41822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E5092693-4E76-6B26-6603-F1BCAA2846C4}"/>
                </a:ext>
              </a:extLst>
            </p:cNvPr>
            <p:cNvSpPr/>
            <p:nvPr/>
          </p:nvSpPr>
          <p:spPr>
            <a:xfrm>
              <a:off x="2253297" y="1092816"/>
              <a:ext cx="2656315" cy="41822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20CA293-FEDB-E1B3-4B97-F67103A24428}"/>
                </a:ext>
              </a:extLst>
            </p:cNvPr>
            <p:cNvSpPr/>
            <p:nvPr/>
          </p:nvSpPr>
          <p:spPr>
            <a:xfrm>
              <a:off x="7459081" y="1090903"/>
              <a:ext cx="2460947" cy="418229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2041623-A3ED-D0F3-40F9-39656F5D0D29}"/>
                </a:ext>
              </a:extLst>
            </p:cNvPr>
            <p:cNvSpPr txBox="1"/>
            <p:nvPr/>
          </p:nvSpPr>
          <p:spPr>
            <a:xfrm>
              <a:off x="8076502" y="1274195"/>
              <a:ext cx="1686488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11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46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2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466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2nM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16C9987-560D-8C3D-0D5F-51B01C85D5DD}"/>
                </a:ext>
              </a:extLst>
            </p:cNvPr>
            <p:cNvSpPr txBox="1"/>
            <p:nvPr/>
          </p:nvSpPr>
          <p:spPr>
            <a:xfrm>
              <a:off x="6680293" y="1911997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1056B1D-C1D8-49CC-DECB-A8180954C435}"/>
                </a:ext>
              </a:extLst>
            </p:cNvPr>
            <p:cNvSpPr txBox="1"/>
            <p:nvPr/>
          </p:nvSpPr>
          <p:spPr>
            <a:xfrm>
              <a:off x="6985568" y="1748154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F2D5688-7953-6B1B-661B-4E8E7B880F0B}"/>
                </a:ext>
              </a:extLst>
            </p:cNvPr>
            <p:cNvSpPr txBox="1"/>
            <p:nvPr/>
          </p:nvSpPr>
          <p:spPr>
            <a:xfrm>
              <a:off x="9258564" y="2388430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6070467-DBAF-92C6-6CE9-7BF186DD3A6D}"/>
                </a:ext>
              </a:extLst>
            </p:cNvPr>
            <p:cNvSpPr txBox="1"/>
            <p:nvPr/>
          </p:nvSpPr>
          <p:spPr>
            <a:xfrm>
              <a:off x="9572469" y="1728413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59095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FB3E35F0-B252-2BDD-8A64-A0E3ECFB2492}"/>
              </a:ext>
            </a:extLst>
          </p:cNvPr>
          <p:cNvSpPr txBox="1"/>
          <p:nvPr/>
        </p:nvSpPr>
        <p:spPr>
          <a:xfrm>
            <a:off x="96046" y="69205"/>
            <a:ext cx="19862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6C 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C4CD569-D325-A0DD-C5CA-2C88089A8669}"/>
              </a:ext>
            </a:extLst>
          </p:cNvPr>
          <p:cNvGrpSpPr/>
          <p:nvPr/>
        </p:nvGrpSpPr>
        <p:grpSpPr>
          <a:xfrm>
            <a:off x="517223" y="4158111"/>
            <a:ext cx="9653071" cy="2652154"/>
            <a:chOff x="517223" y="4158111"/>
            <a:chExt cx="9653071" cy="265215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0F8349EF-B0D0-4312-99C6-BC03C96324BA}"/>
                </a:ext>
              </a:extLst>
            </p:cNvPr>
            <p:cNvGrpSpPr/>
            <p:nvPr/>
          </p:nvGrpSpPr>
          <p:grpSpPr>
            <a:xfrm>
              <a:off x="517223" y="4158111"/>
              <a:ext cx="9653071" cy="2652154"/>
              <a:chOff x="517223" y="4158111"/>
              <a:chExt cx="9653071" cy="2652154"/>
            </a:xfrm>
          </p:grpSpPr>
          <p:pic>
            <p:nvPicPr>
              <p:cNvPr id="4098" name="Picture 2" descr="Image preview">
                <a:extLst>
                  <a:ext uri="{FF2B5EF4-FFF2-40B4-BE49-F238E27FC236}">
                    <a16:creationId xmlns:a16="http://schemas.microsoft.com/office/drawing/2014/main" id="{011653A1-6563-476B-B51F-0542200695F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92" t="12330" r="1667" b="3557"/>
              <a:stretch/>
            </p:blipFill>
            <p:spPr bwMode="auto">
              <a:xfrm>
                <a:off x="517223" y="4158111"/>
                <a:ext cx="4823899" cy="26521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100" name="Picture 4" descr="Image preview">
                <a:extLst>
                  <a:ext uri="{FF2B5EF4-FFF2-40B4-BE49-F238E27FC236}">
                    <a16:creationId xmlns:a16="http://schemas.microsoft.com/office/drawing/2014/main" id="{524C2DB1-B7A5-49C3-8FA2-4CC90C9388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20" t="11787" r="1905" b="3738"/>
              <a:stretch/>
            </p:blipFill>
            <p:spPr bwMode="auto">
              <a:xfrm>
                <a:off x="5412094" y="4170181"/>
                <a:ext cx="4758200" cy="264008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3FAAD99-7B93-7A12-EA9C-A298264D65A4}"/>
                </a:ext>
              </a:extLst>
            </p:cNvPr>
            <p:cNvSpPr txBox="1"/>
            <p:nvPr/>
          </p:nvSpPr>
          <p:spPr>
            <a:xfrm>
              <a:off x="1925041" y="4334639"/>
              <a:ext cx="181053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138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20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14.5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20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14.5nM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55BD8D-BDA2-E143-FC0A-1AA0649487AC}"/>
                </a:ext>
              </a:extLst>
            </p:cNvPr>
            <p:cNvSpPr txBox="1"/>
            <p:nvPr/>
          </p:nvSpPr>
          <p:spPr>
            <a:xfrm>
              <a:off x="2334339" y="516017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E795D7D-AD39-E921-9907-E14A2609299D}"/>
                </a:ext>
              </a:extLst>
            </p:cNvPr>
            <p:cNvSpPr txBox="1"/>
            <p:nvPr/>
          </p:nvSpPr>
          <p:spPr>
            <a:xfrm>
              <a:off x="2657890" y="532774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F85AF56-5F91-9C75-3E82-B30933B4A02F}"/>
                </a:ext>
              </a:extLst>
            </p:cNvPr>
            <p:cNvSpPr txBox="1"/>
            <p:nvPr/>
          </p:nvSpPr>
          <p:spPr>
            <a:xfrm>
              <a:off x="7189206" y="526192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62EF1CE-1304-5BF0-7F47-B30F3B36B0C9}"/>
                </a:ext>
              </a:extLst>
            </p:cNvPr>
            <p:cNvSpPr txBox="1"/>
            <p:nvPr/>
          </p:nvSpPr>
          <p:spPr>
            <a:xfrm>
              <a:off x="7511302" y="535079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C6270CD-C019-AAC6-43F8-83A23F1660C3}"/>
                </a:ext>
              </a:extLst>
            </p:cNvPr>
            <p:cNvSpPr txBox="1"/>
            <p:nvPr/>
          </p:nvSpPr>
          <p:spPr>
            <a:xfrm>
              <a:off x="6568830" y="4383881"/>
              <a:ext cx="2008263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TOPO (58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V-DTX (233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TRO-TOPO (6nM)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MBI-CONV-DTX (233nM)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+METRO-TOPO (6nM)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609DE74-1A46-B8BF-855A-4AA20C948A09}"/>
              </a:ext>
            </a:extLst>
          </p:cNvPr>
          <p:cNvGrpSpPr/>
          <p:nvPr/>
        </p:nvGrpSpPr>
        <p:grpSpPr>
          <a:xfrm>
            <a:off x="176028" y="318114"/>
            <a:ext cx="12335016" cy="4067424"/>
            <a:chOff x="176028" y="318114"/>
            <a:chExt cx="12335016" cy="406742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DA834049-FE8C-4700-8231-7590F8A79790}"/>
                </a:ext>
              </a:extLst>
            </p:cNvPr>
            <p:cNvGrpSpPr/>
            <p:nvPr/>
          </p:nvGrpSpPr>
          <p:grpSpPr>
            <a:xfrm>
              <a:off x="176028" y="318114"/>
              <a:ext cx="12335016" cy="4067424"/>
              <a:chOff x="176028" y="318114"/>
              <a:chExt cx="12335016" cy="4067424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814EF642-3C03-4D9A-B21F-C55810F8E5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00131" y="2406975"/>
                <a:ext cx="2314097" cy="1708409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138BFC0A-38E7-4562-8C46-A6C687995E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166647" y="2406974"/>
                <a:ext cx="2314095" cy="1708408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4A782D0-5A92-4A97-9C17-EB95C8FFBB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9842684" y="2406974"/>
                <a:ext cx="2314095" cy="1708408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C886915B-D8AB-45D5-8E57-EE48AE7EFB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499903" y="2406974"/>
                <a:ext cx="2314096" cy="1708408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C95FF854-D716-4A20-8BCE-8DBCA8B64B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833390" y="2406974"/>
                <a:ext cx="2314096" cy="1708409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7FE7BD18-4021-41A5-A973-727D132D26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5166647" y="528020"/>
                <a:ext cx="2314097" cy="1708409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8C815364-B363-4E0A-86A0-889D6F6CF1D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840900" y="522040"/>
                <a:ext cx="2314095" cy="1708408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01387C9-050B-47FB-AD01-C0B62FE826D4}"/>
                  </a:ext>
                </a:extLst>
              </p:cNvPr>
              <p:cNvSpPr txBox="1"/>
              <p:nvPr/>
            </p:nvSpPr>
            <p:spPr>
              <a:xfrm rot="16200000">
                <a:off x="-17342" y="3130373"/>
                <a:ext cx="6735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UTXR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5D7AFB3-BEEF-46E5-84F6-2EE903CCA9B7}"/>
                  </a:ext>
                </a:extLst>
              </p:cNvPr>
              <p:cNvSpPr txBox="1"/>
              <p:nvPr/>
            </p:nvSpPr>
            <p:spPr>
              <a:xfrm rot="16200000">
                <a:off x="-5112" y="1005318"/>
                <a:ext cx="62388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C-3M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7BD0329-F90A-4C7E-A9D6-E740E01F5C56}"/>
                  </a:ext>
                </a:extLst>
              </p:cNvPr>
              <p:cNvSpPr txBox="1"/>
              <p:nvPr/>
            </p:nvSpPr>
            <p:spPr>
              <a:xfrm>
                <a:off x="3313402" y="336909"/>
                <a:ext cx="14718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TOPO (</a:t>
                </a:r>
                <a:r>
                  <a:rPr lang="en-US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8</a:t>
                </a:r>
                <a:r>
                  <a:rPr kumimoji="0" lang="en-US" sz="1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98EFDE0-7620-4232-89AB-A90C5A40E861}"/>
                  </a:ext>
                </a:extLst>
              </p:cNvPr>
              <p:cNvSpPr txBox="1"/>
              <p:nvPr/>
            </p:nvSpPr>
            <p:spPr>
              <a:xfrm>
                <a:off x="5760826" y="326660"/>
                <a:ext cx="165317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DTX (20nM)</a:t>
                </a:r>
                <a:endPara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600EDB1-CFF4-4249-BA44-0346DF96E1FF}"/>
                  </a:ext>
                </a:extLst>
              </p:cNvPr>
              <p:cNvSpPr txBox="1"/>
              <p:nvPr/>
            </p:nvSpPr>
            <p:spPr>
              <a:xfrm>
                <a:off x="7889816" y="323445"/>
                <a:ext cx="1761365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TRO-TOPO (</a:t>
                </a:r>
                <a:r>
                  <a:rPr lang="en-US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4.5</a:t>
                </a:r>
                <a:r>
                  <a:rPr kumimoji="0" lang="en-US" sz="1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6B839CB-3DC4-4B79-8548-C72F1B3319C7}"/>
                  </a:ext>
                </a:extLst>
              </p:cNvPr>
              <p:cNvSpPr txBox="1"/>
              <p:nvPr/>
            </p:nvSpPr>
            <p:spPr>
              <a:xfrm>
                <a:off x="9507984" y="318114"/>
                <a:ext cx="2840684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DTX (20nM</a:t>
                </a:r>
                <a:r>
                  <a:rPr lang="en-US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+METRO-TOPO (</a:t>
                </a:r>
                <a:r>
                  <a:rPr lang="en-US" sz="10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4.5</a:t>
                </a:r>
                <a:r>
                  <a:rPr kumimoji="0" lang="en-US" sz="10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5D0AA6B-CE5C-496A-9EC5-4349ACD47369}"/>
                  </a:ext>
                </a:extLst>
              </p:cNvPr>
              <p:cNvSpPr txBox="1"/>
              <p:nvPr/>
            </p:nvSpPr>
            <p:spPr>
              <a:xfrm>
                <a:off x="575330" y="342901"/>
                <a:ext cx="217399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TROL(CONT)-No Treatment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AD15D5F-0740-4716-B497-841B0130C7A2}"/>
                  </a:ext>
                </a:extLst>
              </p:cNvPr>
              <p:cNvSpPr txBox="1"/>
              <p:nvPr/>
            </p:nvSpPr>
            <p:spPr>
              <a:xfrm>
                <a:off x="3371110" y="2209548"/>
                <a:ext cx="14093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TOPO (58nM)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B854557E-DC18-4D53-8A67-6F85A030857B}"/>
                  </a:ext>
                </a:extLst>
              </p:cNvPr>
              <p:cNvSpPr txBox="1"/>
              <p:nvPr/>
            </p:nvSpPr>
            <p:spPr>
              <a:xfrm>
                <a:off x="5660822" y="2209548"/>
                <a:ext cx="150915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DTX (233nM)</a:t>
                </a:r>
                <a:endPara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F688F4AA-FFE0-4D12-8C94-D238F8603FCB}"/>
                  </a:ext>
                </a:extLst>
              </p:cNvPr>
              <p:cNvSpPr txBox="1"/>
              <p:nvPr/>
            </p:nvSpPr>
            <p:spPr>
              <a:xfrm>
                <a:off x="8005906" y="2214162"/>
                <a:ext cx="150915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ETRO-TOPO (6nM)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EDBA2EA-E83D-4476-98A0-232CF4C40CC3}"/>
                  </a:ext>
                </a:extLst>
              </p:cNvPr>
              <p:cNvSpPr txBox="1"/>
              <p:nvPr/>
            </p:nvSpPr>
            <p:spPr>
              <a:xfrm>
                <a:off x="9582204" y="2231254"/>
                <a:ext cx="2928840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V-DTX (233nM)+METRO-TOPO (6nM)</a:t>
                </a:r>
                <a:endPara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FAFD2FDA-4EDF-418D-850B-A166ADC24095}"/>
                  </a:ext>
                </a:extLst>
              </p:cNvPr>
              <p:cNvSpPr txBox="1"/>
              <p:nvPr/>
            </p:nvSpPr>
            <p:spPr>
              <a:xfrm>
                <a:off x="625285" y="2213356"/>
                <a:ext cx="21387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NTROL(CONT)-No Treatment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E611C6F4-DB01-41BA-B25F-E1673FB32C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0131" y="517255"/>
                <a:ext cx="2314097" cy="1708409"/>
              </a:xfrm>
              <a:prstGeom prst="rect">
                <a:avLst/>
              </a:prstGeom>
            </p:spPr>
          </p:pic>
          <p:pic>
            <p:nvPicPr>
              <p:cNvPr id="13" name="Picture 12" descr="A picture containing outdoor object, colorful&#10;&#10;Description automatically generated">
                <a:extLst>
                  <a:ext uri="{FF2B5EF4-FFF2-40B4-BE49-F238E27FC236}">
                    <a16:creationId xmlns:a16="http://schemas.microsoft.com/office/drawing/2014/main" id="{2D61DEBA-50F5-47AA-BE2A-61A347395B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41274" y="528020"/>
                <a:ext cx="2314095" cy="1708408"/>
              </a:xfrm>
              <a:prstGeom prst="rect">
                <a:avLst/>
              </a:prstGeom>
            </p:spPr>
          </p:pic>
          <p:pic>
            <p:nvPicPr>
              <p:cNvPr id="15" name="Picture 14" descr="A picture containing outdoor object&#10;&#10;Description automatically generated">
                <a:extLst>
                  <a:ext uri="{FF2B5EF4-FFF2-40B4-BE49-F238E27FC236}">
                    <a16:creationId xmlns:a16="http://schemas.microsoft.com/office/drawing/2014/main" id="{290148E6-58BF-4517-8EA9-CD93ED4C30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07414" y="528021"/>
                <a:ext cx="2314095" cy="1708408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30D48732-3E71-4946-A6F3-F9925C1832BE}"/>
                  </a:ext>
                </a:extLst>
              </p:cNvPr>
              <p:cNvSpPr txBox="1"/>
              <p:nvPr/>
            </p:nvSpPr>
            <p:spPr>
              <a:xfrm>
                <a:off x="1550360" y="4123928"/>
                <a:ext cx="2185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1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 Morphology- PC-3M</a:t>
                </a:r>
                <a:r>
                  <a:rPr kumimoji="0" lang="en-US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C</a:t>
                </a:r>
                <a:r>
                  <a:rPr kumimoji="0" lang="en-US" sz="11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/2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E906C1B-27F5-4A7C-B501-E354E88DE327}"/>
                  </a:ext>
                </a:extLst>
              </p:cNvPr>
              <p:cNvSpPr txBox="1"/>
              <p:nvPr/>
            </p:nvSpPr>
            <p:spPr>
              <a:xfrm>
                <a:off x="6271214" y="4122271"/>
                <a:ext cx="223490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1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 Morphology- DUTXR</a:t>
                </a:r>
                <a:r>
                  <a:rPr kumimoji="0" lang="en-US" sz="11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IC</a:t>
                </a:r>
                <a:r>
                  <a:rPr kumimoji="0" lang="en-US" sz="1100" b="1" i="0" u="none" strike="noStrike" kern="0" cap="none" spc="0" normalizeH="0" baseline="-25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0/2</a:t>
                </a: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992C342-7881-F913-B0DE-0DEBB83495DF}"/>
                </a:ext>
              </a:extLst>
            </p:cNvPr>
            <p:cNvSpPr txBox="1"/>
            <p:nvPr/>
          </p:nvSpPr>
          <p:spPr>
            <a:xfrm>
              <a:off x="10941026" y="3985646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DBB1093-AC4F-6D45-E478-49A04D674D62}"/>
                </a:ext>
              </a:extLst>
            </p:cNvPr>
            <p:cNvSpPr txBox="1"/>
            <p:nvPr/>
          </p:nvSpPr>
          <p:spPr>
            <a:xfrm>
              <a:off x="8585639" y="3995068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351D1E22-A9FC-3C3E-64C5-AE72C9ABCE11}"/>
                </a:ext>
              </a:extLst>
            </p:cNvPr>
            <p:cNvSpPr txBox="1"/>
            <p:nvPr/>
          </p:nvSpPr>
          <p:spPr>
            <a:xfrm>
              <a:off x="6245828" y="3993662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86BE7A5-FCEF-3373-85BF-814A7FAD3A41}"/>
                </a:ext>
              </a:extLst>
            </p:cNvPr>
            <p:cNvSpPr txBox="1"/>
            <p:nvPr/>
          </p:nvSpPr>
          <p:spPr>
            <a:xfrm>
              <a:off x="3929741" y="3985100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1EA8D83-0987-05EC-4656-14065C3CBF4E}"/>
                </a:ext>
              </a:extLst>
            </p:cNvPr>
            <p:cNvSpPr txBox="1"/>
            <p:nvPr/>
          </p:nvSpPr>
          <p:spPr>
            <a:xfrm>
              <a:off x="1605030" y="3992371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8883458-0A73-9BE2-FBCA-AF10ABD1A239}"/>
                </a:ext>
              </a:extLst>
            </p:cNvPr>
            <p:cNvSpPr txBox="1"/>
            <p:nvPr/>
          </p:nvSpPr>
          <p:spPr>
            <a:xfrm>
              <a:off x="10928326" y="2104417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EEE84C4-A038-7A7F-3041-55B13E15C94E}"/>
                </a:ext>
              </a:extLst>
            </p:cNvPr>
            <p:cNvSpPr txBox="1"/>
            <p:nvPr/>
          </p:nvSpPr>
          <p:spPr>
            <a:xfrm>
              <a:off x="8594185" y="2103869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EC995AB-7D41-ABDC-61F2-6E1BDD23E668}"/>
                </a:ext>
              </a:extLst>
            </p:cNvPr>
            <p:cNvSpPr txBox="1"/>
            <p:nvPr/>
          </p:nvSpPr>
          <p:spPr>
            <a:xfrm>
              <a:off x="6262668" y="2103869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81AADF5-0C00-655C-AB69-BCCA8371AB16}"/>
                </a:ext>
              </a:extLst>
            </p:cNvPr>
            <p:cNvSpPr txBox="1"/>
            <p:nvPr/>
          </p:nvSpPr>
          <p:spPr>
            <a:xfrm>
              <a:off x="3939323" y="2104417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C9894B1-5825-E994-3A41-89A1F0DDCF8A}"/>
                </a:ext>
              </a:extLst>
            </p:cNvPr>
            <p:cNvSpPr txBox="1"/>
            <p:nvPr/>
          </p:nvSpPr>
          <p:spPr>
            <a:xfrm>
              <a:off x="1593580" y="2095708"/>
              <a:ext cx="1170432" cy="914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18288" rIns="0" bIns="0" rtlCol="0">
              <a:normAutofit fontScale="47500" lnSpcReduction="20000"/>
            </a:bodyPr>
            <a:lstStyle/>
            <a:p>
              <a:pPr algn="ctr"/>
              <a:r>
                <a:rPr lang="en-US" sz="1000" dirty="0"/>
                <a:t>1000 </a:t>
              </a:r>
              <a:r>
                <a:rPr lang="en-US" sz="1000" dirty="0">
                  <a:latin typeface="Symbol" pitchFamily="2" charset="2"/>
                </a:rPr>
                <a:t>m</a:t>
              </a:r>
              <a:r>
                <a:rPr lang="en-US" sz="1000" dirty="0"/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20119603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36</TotalTime>
  <Words>499</Words>
  <Application>Microsoft Office PowerPoint</Application>
  <PresentationFormat>Widescreen</PresentationFormat>
  <Paragraphs>90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2_Office Theme</vt:lpstr>
      <vt:lpstr>1_Office Theme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aswi Mitra Ghosh</dc:creator>
  <cp:lastModifiedBy>AMIT MITRA</cp:lastModifiedBy>
  <cp:revision>114</cp:revision>
  <cp:lastPrinted>2022-04-06T04:19:54Z</cp:lastPrinted>
  <dcterms:created xsi:type="dcterms:W3CDTF">2021-11-23T16:14:52Z</dcterms:created>
  <dcterms:modified xsi:type="dcterms:W3CDTF">2023-05-31T16:11:00Z</dcterms:modified>
</cp:coreProperties>
</file>